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22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-9-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1155516"/>
            <a:ext cx="8208912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ig. S1 GO enrichment analysis of DMR-related genes in five SV plants. Annotations are grouped into the terms of cellular components, molecular function or biological process. A, GO enrichment of CK-VS-WS; B, GO enrichment of CK-VS-YS; C, GO enrichment of CK-VS-GS; D, GO enrichment of CK-VS-LS; E, GO enrichment of CK-VS-TP. Gene numbers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listed for each category. </a:t>
            </a:r>
          </a:p>
          <a:p>
            <a:pPr>
              <a:lnSpc>
                <a:spcPct val="150000"/>
              </a:lnSpc>
            </a:pP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 Fig. S2 Pathway assignment based on KEGG in five SV plants. A, Pathway analysis of gene body DMRs-related genes between CK and WS; B, Pathway analysis of gene body DMRs-related genes between CK and YS; C, Pathway analysis of gene body DMRs-related genes between CK and GS; D, Pathway analysis of gene body DMRs-related genes between CK and LS; E, Pathway analysis of gene body DMRs-related genes between CK and TP. </a:t>
            </a:r>
            <a:endParaRPr lang="zh-CN" altLang="en-US" sz="16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57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123</dc:creator>
  <cp:lastModifiedBy>123</cp:lastModifiedBy>
  <cp:revision>4</cp:revision>
  <dcterms:created xsi:type="dcterms:W3CDTF">2019-08-07T03:11:47Z</dcterms:created>
  <dcterms:modified xsi:type="dcterms:W3CDTF">2019-09-26T03:47:37Z</dcterms:modified>
</cp:coreProperties>
</file>